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7" r:id="rId2"/>
  </p:sldIdLst>
  <p:sldSz cx="9144000" cy="6858000" type="screen4x3"/>
  <p:notesSz cx="6807200" cy="99393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  <a:srgbClr val="00B050"/>
    <a:srgbClr val="0066FF"/>
    <a:srgbClr val="D50505"/>
    <a:srgbClr val="F9B88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882" autoAdjust="0"/>
    <p:restoredTop sz="99769" autoAdjust="0"/>
  </p:normalViewPr>
  <p:slideViewPr>
    <p:cSldViewPr>
      <p:cViewPr varScale="1">
        <p:scale>
          <a:sx n="102" d="100"/>
          <a:sy n="102" d="100"/>
        </p:scale>
        <p:origin x="120" y="96"/>
      </p:cViewPr>
      <p:guideLst>
        <p:guide orient="horz" pos="2160"/>
        <p:guide pos="2880"/>
      </p:guideLst>
    </p:cSldViewPr>
  </p:slideViewPr>
  <p:notesTextViewPr>
    <p:cViewPr>
      <p:scale>
        <a:sx n="125" d="100"/>
        <a:sy n="12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45436;&#47928;\&#45436;&#47928;%20&#51089;&#49457;\&#49345;&#52628;\1.%20&#54408;&#51333;&#49885;&#48324;&#47560;&#52964;\&#49345;&#52628;&#54408;&#51333;&#49885;&#48324;&#47560;&#52964;%20&#44288;&#47144;%20&#45936;&#51060;&#53552;\structure%20delta%20kgraph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DeltaK = mean(|L''(K)|) / sd(L(K))</a:t>
            </a:r>
          </a:p>
        </c:rich>
      </c:tx>
      <c:layout>
        <c:manualLayout>
          <c:xMode val="edge"/>
          <c:yMode val="edge"/>
          <c:x val="0.30131991507116496"/>
          <c:y val="5.1203988087345137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3323704773543679"/>
          <c:y val="0.16066763191186642"/>
          <c:w val="0.80093353824883651"/>
          <c:h val="0.693471334726249"/>
        </c:manualLayout>
      </c:layout>
      <c:lineChart>
        <c:grouping val="standard"/>
        <c:varyColors val="0"/>
        <c:ser>
          <c:idx val="0"/>
          <c:order val="0"/>
          <c:tx>
            <c:strRef>
              <c:f>'Fig S1. Delta K 수정'!$D$2</c:f>
              <c:strCache>
                <c:ptCount val="1"/>
                <c:pt idx="0">
                  <c:v>Delta K</c:v>
                </c:pt>
              </c:strCache>
            </c:strRef>
          </c:tx>
          <c:marker>
            <c:symbol val="circle"/>
            <c:size val="5"/>
          </c:marker>
          <c:cat>
            <c:numRef>
              <c:f>'Fig S1. Delta K 수정'!$C$3:$C$10</c:f>
              <c:numCache>
                <c:formatCode>General</c:formatCode>
                <c:ptCount val="8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</c:numCache>
            </c:numRef>
          </c:cat>
          <c:val>
            <c:numRef>
              <c:f>'Fig S1. Delta K 수정'!$D$3:$D$10</c:f>
              <c:numCache>
                <c:formatCode>General</c:formatCode>
                <c:ptCount val="8"/>
                <c:pt idx="0">
                  <c:v>150</c:v>
                </c:pt>
                <c:pt idx="1">
                  <c:v>100</c:v>
                </c:pt>
                <c:pt idx="2">
                  <c:v>2180</c:v>
                </c:pt>
                <c:pt idx="3">
                  <c:v>0</c:v>
                </c:pt>
                <c:pt idx="4">
                  <c:v>820</c:v>
                </c:pt>
                <c:pt idx="5">
                  <c:v>50</c:v>
                </c:pt>
                <c:pt idx="6">
                  <c:v>50</c:v>
                </c:pt>
                <c:pt idx="7">
                  <c:v>5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ABD-4BA9-8F87-885EA6BC00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hiLowLines/>
        <c:marker val="1"/>
        <c:smooth val="0"/>
        <c:axId val="213984256"/>
        <c:axId val="208764928"/>
      </c:lineChart>
      <c:catAx>
        <c:axId val="21398425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Number of subpopulation (K)</a:t>
                </a:r>
                <a:endParaRPr lang="ko-KR"/>
              </a:p>
            </c:rich>
          </c:tx>
          <c:layout>
            <c:manualLayout>
              <c:xMode val="edge"/>
              <c:yMode val="edge"/>
              <c:x val="0.37915447666308683"/>
              <c:y val="0.94987160924771796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crossAx val="208764928"/>
        <c:crosses val="autoZero"/>
        <c:auto val="1"/>
        <c:lblAlgn val="ctr"/>
        <c:lblOffset val="100"/>
        <c:noMultiLvlLbl val="0"/>
      </c:catAx>
      <c:valAx>
        <c:axId val="208764928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Delta K</a:t>
                </a:r>
                <a:endParaRPr lang="ko-KR"/>
              </a:p>
            </c:rich>
          </c:tx>
          <c:layout>
            <c:manualLayout>
              <c:xMode val="edge"/>
              <c:yMode val="edge"/>
              <c:x val="1.4878285128812847E-2"/>
              <c:y val="0.434713123273041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21398425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Times New Roman" pitchFamily="18" charset="0"/>
          <a:cs typeface="Times New Roman" pitchFamily="18" charset="0"/>
        </a:defRPr>
      </a:pPr>
      <a:endParaRPr lang="ko-KR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FDA6AA9-4F33-46C6-B302-B5591502A1AB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920750" y="746125"/>
            <a:ext cx="4965700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0720" y="4721186"/>
            <a:ext cx="5445760" cy="447270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5838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A98017-DADE-4380-BED9-5B01BFC806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262327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97530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674353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287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82594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503209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194072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718566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100456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86269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9341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27855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84084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611560" y="5459450"/>
            <a:ext cx="7416824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Fig. S1. Values of delta K (ΔK) in 96 lettuce cultivars assumed based </a:t>
            </a:r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on 17,877 SNPs from </a:t>
            </a:r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STRUCTURE analysis.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Delta K graph determined the maximum value at K=4.</a:t>
            </a:r>
            <a:endParaRPr lang="ko-KR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6" name="차트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70178424"/>
              </p:ext>
            </p:extLst>
          </p:nvPr>
        </p:nvGraphicFramePr>
        <p:xfrm>
          <a:off x="1115616" y="620688"/>
          <a:ext cx="6480720" cy="44644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2935507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167</TotalTime>
  <Words>53</Words>
  <Application>Microsoft Office PowerPoint</Application>
  <PresentationFormat>화면 슬라이드 쇼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evelopment of SNP markers for genetic diversity assessment in lettuce varieties (Lactuca sativa L.)</dc:title>
  <dc:creator>User</dc:creator>
  <cp:lastModifiedBy>User</cp:lastModifiedBy>
  <cp:revision>352</cp:revision>
  <cp:lastPrinted>2021-06-21T07:24:34Z</cp:lastPrinted>
  <dcterms:created xsi:type="dcterms:W3CDTF">2020-06-02T04:33:11Z</dcterms:created>
  <dcterms:modified xsi:type="dcterms:W3CDTF">2021-12-24T07:30:53Z</dcterms:modified>
</cp:coreProperties>
</file>